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0"/>
  </p:normalViewPr>
  <p:slideViewPr>
    <p:cSldViewPr snapToGrid="0">
      <p:cViewPr>
        <p:scale>
          <a:sx n="120" d="100"/>
          <a:sy n="120" d="100"/>
        </p:scale>
        <p:origin x="1920" y="-28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709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347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888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161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82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459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148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701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918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361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718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111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BB3651-2CB9-2642-9583-4ED519EAFACE}" type="datetimeFigureOut">
              <a:rPr lang="en-US" smtClean="0"/>
              <a:t>1/3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453BA4-F11A-5240-B032-C96EBDB199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953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line graph&#10;&#10;Description automatically generated with medium confidence">
            <a:extLst>
              <a:ext uri="{FF2B5EF4-FFF2-40B4-BE49-F238E27FC236}">
                <a16:creationId xmlns:a16="http://schemas.microsoft.com/office/drawing/2014/main" id="{7983DD70-7655-6754-5712-4D20F56C9B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573" y="1436544"/>
            <a:ext cx="2957946" cy="221846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CCA8F693-810A-35C0-1527-AF276C7B3BFA}"/>
              </a:ext>
            </a:extLst>
          </p:cNvPr>
          <p:cNvSpPr/>
          <p:nvPr/>
        </p:nvSpPr>
        <p:spPr>
          <a:xfrm>
            <a:off x="987137" y="1394980"/>
            <a:ext cx="1995055" cy="24678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91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DEED92A-FB18-1A66-1346-D8E5735DDF00}"/>
              </a:ext>
            </a:extLst>
          </p:cNvPr>
          <p:cNvSpPr txBox="1"/>
          <p:nvPr/>
        </p:nvSpPr>
        <p:spPr>
          <a:xfrm>
            <a:off x="987137" y="1197215"/>
            <a:ext cx="2202874" cy="5203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eus – </a:t>
            </a:r>
          </a:p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 2015030 Braking</a:t>
            </a:r>
          </a:p>
        </p:txBody>
      </p:sp>
      <p:pic>
        <p:nvPicPr>
          <p:cNvPr id="14" name="Picture 13" descr="A graph of a normal distribution&#10;&#10;Description automatically generated">
            <a:extLst>
              <a:ext uri="{FF2B5EF4-FFF2-40B4-BE49-F238E27FC236}">
                <a16:creationId xmlns:a16="http://schemas.microsoft.com/office/drawing/2014/main" id="{D8D11A55-C0C8-43C8-F22F-8E017545E1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8820" y="1436543"/>
            <a:ext cx="2957946" cy="2218460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BABDA6A8-9099-3DF3-B30D-6F7F4C6912D6}"/>
              </a:ext>
            </a:extLst>
          </p:cNvPr>
          <p:cNvSpPr/>
          <p:nvPr/>
        </p:nvSpPr>
        <p:spPr>
          <a:xfrm>
            <a:off x="4095071" y="1449869"/>
            <a:ext cx="2005445" cy="24678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91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C9A4B82-5D95-66BA-7BC1-B4834E04907A}"/>
              </a:ext>
            </a:extLst>
          </p:cNvPr>
          <p:cNvSpPr txBox="1"/>
          <p:nvPr/>
        </p:nvSpPr>
        <p:spPr>
          <a:xfrm>
            <a:off x="4095070" y="1186825"/>
            <a:ext cx="2202874" cy="5203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eus – </a:t>
            </a:r>
          </a:p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 2014048 Propulsion</a:t>
            </a:r>
          </a:p>
        </p:txBody>
      </p:sp>
      <p:pic>
        <p:nvPicPr>
          <p:cNvPr id="20" name="Picture 19" descr="A graph of a sleep&#10;&#10;Description automatically generated">
            <a:extLst>
              <a:ext uri="{FF2B5EF4-FFF2-40B4-BE49-F238E27FC236}">
                <a16:creationId xmlns:a16="http://schemas.microsoft.com/office/drawing/2014/main" id="{4E27D841-D0BB-C5F3-CB8B-8F03B567D8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573" y="3986213"/>
            <a:ext cx="2957947" cy="2218460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684B2E50-3802-E1E9-90DE-801F2ECA3907}"/>
              </a:ext>
            </a:extLst>
          </p:cNvPr>
          <p:cNvSpPr/>
          <p:nvPr/>
        </p:nvSpPr>
        <p:spPr>
          <a:xfrm>
            <a:off x="926487" y="3986213"/>
            <a:ext cx="2410691" cy="15846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91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714EC02-A735-5F3D-550F-49A007DDED92}"/>
              </a:ext>
            </a:extLst>
          </p:cNvPr>
          <p:cNvSpPr txBox="1"/>
          <p:nvPr/>
        </p:nvSpPr>
        <p:spPr>
          <a:xfrm>
            <a:off x="1030395" y="3736494"/>
            <a:ext cx="2202874" cy="5203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strocnemius Lateralis – </a:t>
            </a:r>
          </a:p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 2014019 Braking</a:t>
            </a:r>
          </a:p>
        </p:txBody>
      </p:sp>
      <p:pic>
        <p:nvPicPr>
          <p:cNvPr id="31" name="Picture 30" descr="A graph of a sleep&#10;&#10;Description automatically generated">
            <a:extLst>
              <a:ext uri="{FF2B5EF4-FFF2-40B4-BE49-F238E27FC236}">
                <a16:creationId xmlns:a16="http://schemas.microsoft.com/office/drawing/2014/main" id="{89E319B4-4D50-A6BE-096E-83B9DECF0FF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3454" y="3986213"/>
            <a:ext cx="2957947" cy="2218460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FE547AA1-923B-7DAF-62A9-B25CC2E9FC8B}"/>
              </a:ext>
            </a:extLst>
          </p:cNvPr>
          <p:cNvSpPr/>
          <p:nvPr/>
        </p:nvSpPr>
        <p:spPr>
          <a:xfrm>
            <a:off x="3997347" y="4024154"/>
            <a:ext cx="2300598" cy="1205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91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DF427B9-3E1D-FDE5-7318-CA764496C499}"/>
              </a:ext>
            </a:extLst>
          </p:cNvPr>
          <p:cNvSpPr txBox="1"/>
          <p:nvPr/>
        </p:nvSpPr>
        <p:spPr>
          <a:xfrm>
            <a:off x="4095070" y="3736493"/>
            <a:ext cx="2202874" cy="5203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strocnemius Lateralis – </a:t>
            </a:r>
          </a:p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 2014051 Propulsion</a:t>
            </a:r>
          </a:p>
        </p:txBody>
      </p:sp>
      <p:pic>
        <p:nvPicPr>
          <p:cNvPr id="37" name="Picture 36" descr="A graph of a normal sleep&#10;&#10;Description automatically generated with medium confidence">
            <a:extLst>
              <a:ext uri="{FF2B5EF4-FFF2-40B4-BE49-F238E27FC236}">
                <a16:creationId xmlns:a16="http://schemas.microsoft.com/office/drawing/2014/main" id="{53F57392-781A-6266-70EC-6C498809D9C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573" y="6467229"/>
            <a:ext cx="2957946" cy="2218460"/>
          </a:xfrm>
          <a:prstGeom prst="rect">
            <a:avLst/>
          </a:prstGeom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3AF30B42-E132-A008-13AD-BF1B12B00211}"/>
              </a:ext>
            </a:extLst>
          </p:cNvPr>
          <p:cNvSpPr/>
          <p:nvPr/>
        </p:nvSpPr>
        <p:spPr>
          <a:xfrm>
            <a:off x="933847" y="6474994"/>
            <a:ext cx="2306783" cy="1474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91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5CC4AF6-E884-BB1C-BA1E-CB58B61B58CF}"/>
              </a:ext>
            </a:extLst>
          </p:cNvPr>
          <p:cNvSpPr txBox="1"/>
          <p:nvPr/>
        </p:nvSpPr>
        <p:spPr>
          <a:xfrm>
            <a:off x="1070917" y="6244686"/>
            <a:ext cx="2202874" cy="5203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strocnemius Medialis – </a:t>
            </a:r>
          </a:p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 2014014 Braking</a:t>
            </a:r>
          </a:p>
        </p:txBody>
      </p:sp>
      <p:pic>
        <p:nvPicPr>
          <p:cNvPr id="43" name="Picture 42" descr="A graph of a sleep&#10;&#10;Description automatically generated">
            <a:extLst>
              <a:ext uri="{FF2B5EF4-FFF2-40B4-BE49-F238E27FC236}">
                <a16:creationId xmlns:a16="http://schemas.microsoft.com/office/drawing/2014/main" id="{E7C1CEEB-3958-D078-37AD-4386C0398DD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1461" y="6474995"/>
            <a:ext cx="2957947" cy="2218461"/>
          </a:xfrm>
          <a:prstGeom prst="rect">
            <a:avLst/>
          </a:prstGeom>
        </p:spPr>
      </p:pic>
      <p:sp>
        <p:nvSpPr>
          <p:cNvPr id="47" name="Rectangle 46">
            <a:extLst>
              <a:ext uri="{FF2B5EF4-FFF2-40B4-BE49-F238E27FC236}">
                <a16:creationId xmlns:a16="http://schemas.microsoft.com/office/drawing/2014/main" id="{421FC01F-EBD5-ECF9-A20F-58FA7C5A88E8}"/>
              </a:ext>
            </a:extLst>
          </p:cNvPr>
          <p:cNvSpPr/>
          <p:nvPr/>
        </p:nvSpPr>
        <p:spPr>
          <a:xfrm>
            <a:off x="3997347" y="6461753"/>
            <a:ext cx="2300598" cy="1680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91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DE4DDFB-51B6-4374-7258-9049ABACC7EB}"/>
              </a:ext>
            </a:extLst>
          </p:cNvPr>
          <p:cNvSpPr txBox="1"/>
          <p:nvPr/>
        </p:nvSpPr>
        <p:spPr>
          <a:xfrm>
            <a:off x="4095070" y="6242614"/>
            <a:ext cx="2202874" cy="5203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strocnemius Medialis – </a:t>
            </a:r>
          </a:p>
          <a:p>
            <a:pPr algn="ctr"/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 2014001 Propulsion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5DEEEE5-8EC4-F51F-EA8A-2E91EBD89B3A}"/>
              </a:ext>
            </a:extLst>
          </p:cNvPr>
          <p:cNvSpPr txBox="1"/>
          <p:nvPr/>
        </p:nvSpPr>
        <p:spPr>
          <a:xfrm>
            <a:off x="531803" y="1199592"/>
            <a:ext cx="284445" cy="306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36A648B-67D9-8349-F2A1-6AA444AA43D1}"/>
              </a:ext>
            </a:extLst>
          </p:cNvPr>
          <p:cNvSpPr txBox="1"/>
          <p:nvPr/>
        </p:nvSpPr>
        <p:spPr>
          <a:xfrm>
            <a:off x="3545728" y="1199592"/>
            <a:ext cx="284445" cy="306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9B9DC6B-D025-AE82-5A9B-A20D52939828}"/>
              </a:ext>
            </a:extLst>
          </p:cNvPr>
          <p:cNvSpPr txBox="1"/>
          <p:nvPr/>
        </p:nvSpPr>
        <p:spPr>
          <a:xfrm>
            <a:off x="517517" y="3722843"/>
            <a:ext cx="284445" cy="306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8F34B2B-9897-B4E3-73BF-EF8782E07395}"/>
              </a:ext>
            </a:extLst>
          </p:cNvPr>
          <p:cNvSpPr txBox="1"/>
          <p:nvPr/>
        </p:nvSpPr>
        <p:spPr>
          <a:xfrm>
            <a:off x="3518382" y="3730820"/>
            <a:ext cx="284445" cy="306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3D4C637-9627-AF5C-FCD9-9EF9B67D3878}"/>
              </a:ext>
            </a:extLst>
          </p:cNvPr>
          <p:cNvSpPr txBox="1"/>
          <p:nvPr/>
        </p:nvSpPr>
        <p:spPr>
          <a:xfrm>
            <a:off x="531803" y="6227894"/>
            <a:ext cx="284445" cy="306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72FBF4A-FFE3-5F3A-F238-C740FAA41E62}"/>
              </a:ext>
            </a:extLst>
          </p:cNvPr>
          <p:cNvSpPr txBox="1"/>
          <p:nvPr/>
        </p:nvSpPr>
        <p:spPr>
          <a:xfrm>
            <a:off x="3554567" y="6227894"/>
            <a:ext cx="284445" cy="306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pic>
        <p:nvPicPr>
          <p:cNvPr id="56" name="Picture 55" descr="A graph of a sleep&#10;&#10;Description automatically generated">
            <a:extLst>
              <a:ext uri="{FF2B5EF4-FFF2-40B4-BE49-F238E27FC236}">
                <a16:creationId xmlns:a16="http://schemas.microsoft.com/office/drawing/2014/main" id="{BEE66D87-9445-D2B3-A794-DB3B85D4283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571" t="10952" r="13549" b="78614"/>
          <a:stretch/>
        </p:blipFill>
        <p:spPr>
          <a:xfrm>
            <a:off x="1070917" y="1791823"/>
            <a:ext cx="148071" cy="190262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462CE068-B288-E7F8-1981-D33549EAFC03}"/>
              </a:ext>
            </a:extLst>
          </p:cNvPr>
          <p:cNvSpPr txBox="1"/>
          <p:nvPr/>
        </p:nvSpPr>
        <p:spPr>
          <a:xfrm>
            <a:off x="1195633" y="1705780"/>
            <a:ext cx="687185" cy="211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3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7F6D1E6-527C-2470-013D-0FBDF1EE8E75}"/>
              </a:ext>
            </a:extLst>
          </p:cNvPr>
          <p:cNvSpPr txBox="1"/>
          <p:nvPr/>
        </p:nvSpPr>
        <p:spPr>
          <a:xfrm>
            <a:off x="1195634" y="1788349"/>
            <a:ext cx="654415" cy="211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3" dirty="0">
                <a:latin typeface="Times New Roman" panose="02020603050405020304" pitchFamily="18" charset="0"/>
                <a:cs typeface="Times New Roman" panose="02020603050405020304" pitchFamily="18" charset="0"/>
              </a:rPr>
              <a:t>YH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48B09DA-4C42-6E3F-9F83-1ED6D8CCB3E6}"/>
              </a:ext>
            </a:extLst>
          </p:cNvPr>
          <p:cNvSpPr txBox="1"/>
          <p:nvPr/>
        </p:nvSpPr>
        <p:spPr>
          <a:xfrm>
            <a:off x="1195635" y="1864078"/>
            <a:ext cx="499670" cy="211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7761578-1C3A-A8CC-995E-858D813F9C25}"/>
              </a:ext>
            </a:extLst>
          </p:cNvPr>
          <p:cNvSpPr txBox="1"/>
          <p:nvPr/>
        </p:nvSpPr>
        <p:spPr>
          <a:xfrm>
            <a:off x="379232" y="575331"/>
            <a:ext cx="2957946" cy="306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20DBDC4-D080-6A71-4506-55DC14E7F3E8}"/>
              </a:ext>
            </a:extLst>
          </p:cNvPr>
          <p:cNvSpPr txBox="1"/>
          <p:nvPr/>
        </p:nvSpPr>
        <p:spPr>
          <a:xfrm>
            <a:off x="1042439" y="8871575"/>
            <a:ext cx="6160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cle force profiles for soleus (A-B), gastrocnemius lateralis (C-D), and gastrocnemius medialis (E-F). Maximum muscle forces occur at similar percent step for all muscle configurations and individuals.</a:t>
            </a:r>
          </a:p>
        </p:txBody>
      </p:sp>
    </p:spTree>
    <p:extLst>
      <p:ext uri="{BB962C8B-B14F-4D97-AF65-F5344CB8AC3E}">
        <p14:creationId xmlns:p14="http://schemas.microsoft.com/office/powerpoint/2010/main" val="823390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81</Words>
  <Application>Microsoft Macintosh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per, Christine</dc:creator>
  <cp:lastModifiedBy>Harper, Christine</cp:lastModifiedBy>
  <cp:revision>5</cp:revision>
  <dcterms:created xsi:type="dcterms:W3CDTF">2025-01-27T19:22:52Z</dcterms:created>
  <dcterms:modified xsi:type="dcterms:W3CDTF">2025-01-30T18:13:06Z</dcterms:modified>
</cp:coreProperties>
</file>